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0" r:id="rId4"/>
    <p:sldId id="261" r:id="rId5"/>
    <p:sldId id="263" r:id="rId6"/>
    <p:sldId id="266" r:id="rId7"/>
    <p:sldId id="265" r:id="rId8"/>
    <p:sldId id="267" r:id="rId9"/>
    <p:sldId id="269" r:id="rId10"/>
    <p:sldId id="270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AB269E3-A360-4502-A209-7B985618E9C1}" v="13" dt="2026-02-11T07:52:03.88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91" autoAdjust="0"/>
    <p:restoredTop sz="94660"/>
  </p:normalViewPr>
  <p:slideViewPr>
    <p:cSldViewPr snapToGrid="0">
      <p:cViewPr varScale="1">
        <p:scale>
          <a:sx n="67" d="100"/>
          <a:sy n="67" d="100"/>
        </p:scale>
        <p:origin x="46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E8E0D0-BFD1-CBA5-BE7B-EFFB49C7F9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90A75D7-30F7-B7AD-21BD-F9E33A81C3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969894-7894-3EAE-1103-6B13DFEA3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811BA6-6589-5856-CCB3-3D982B47D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D77450-3EA7-0FD0-E9D6-7C965D740D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748928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C42292-F3C6-AD3F-9D30-932A0ED78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7AD61B-9E12-0F2F-28E7-6CC4276CD3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F68145-6BE2-631D-9ADE-3C83849D0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2F96BB-3782-DDAD-7ACA-F6B58F087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A81260-77ED-4414-9362-B586F1E3D4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930062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B3ED54-BE6D-A376-C28B-B20F18FB8A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33877B-881A-2BAC-E2B9-DEB53562E4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69911-7F6F-FF86-B119-2DD311947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1844B1-7F30-406F-386C-8AB8E9DBA8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8CBFC7-5E58-64AA-91D6-A7D0D298E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32529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B2286C-5EEE-66E8-4F16-1222D9CA42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B0F8B8-D756-4374-C481-6D562D9F02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13796-82FD-EC1D-6163-EDE892456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E28F81-8E3A-EF63-926C-789213F312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659FCC-5269-7B9D-5161-87A2AA58F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035030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82FF20-74EF-CBAE-C4E2-5F73A111A5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0675BE-292C-7036-5EDF-FB1544214E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F32DE2-FF29-0126-23AF-2A09ADDB9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7900FC-987A-0114-97AD-4175141CA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E2E653-E21B-AB37-55D5-EEC9BE48B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366001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4F8083-6C37-B2B5-B759-C10792AB4C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54C62F-1B3B-BB23-F144-E6169E261D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0DA74D-87DD-5FA3-121B-DBCA171F28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62B1F6-088E-D2F7-65E6-0806337A0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95A7B1-8329-C624-818E-BAA07CA13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508CE4-FA42-3096-713A-C9E529C7AC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478290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A5C783-308B-5BFE-66D3-F653AD5A57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0E379D-4A07-678E-0610-7387A8A61E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35CD3C-53DA-7EAC-B779-7948750801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224FA65-35EB-C523-74E1-010F507EE1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F3A174D-124B-9731-74E4-8247CAD70E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8F14C2-E927-EAA8-F80B-99652E60B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EF29CF4-E6CB-5BDE-2E68-5E50AB7AA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FD0A135-27A1-509E-F7EE-F22434AE66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207825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594D7F-2EDB-4F32-59CC-19033297E8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E3D1F0-C98A-9E72-1141-300A57AEA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FA339C8-FBD8-1CA4-65FE-77B605398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4622717-165E-6D3B-BF4D-B78DE1AB7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757677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0A270DE-5720-FC65-1B47-0973FDE26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57130D-D932-191B-EFBF-D92BF5FDE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54F3D1-61D0-229C-C90E-48364E885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1045520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2AE052-7DA6-5C3B-0DC0-6B397992F7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A9F225-7887-DDF3-FEE4-1ABAAC239F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3EC9B6-00C3-4E03-9F0B-56733631A8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370BCF-EEEC-259E-8B96-F874A100E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6B6BF0-17EE-13D7-103D-C9EB39C85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395E6B-32C5-BDBF-FE2F-76ACD44E39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704204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4FC04F-33A9-D185-3E46-17687F871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2A9852F-6509-2286-F2F1-DA92B2A0F5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31DD39-783E-49EA-6498-4904A6C609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CDF2D2-A1DD-EEB4-07B7-2C7858125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56C9E9-6975-78C6-4D46-6309E9D5AD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66072E-9B10-E6A6-3D2A-85069FDDB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37026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892A6E-19F8-139D-6E0D-AB0A2C9F2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798313-221E-E584-65D3-3D9130B537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B0E407-3E8D-C76D-B8D6-CC92BAE37E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BEBBAA-E963-4A53-A34B-7571E499C4CF}" type="datetimeFigureOut">
              <a:rPr lang="en-SG" smtClean="0"/>
              <a:t>11/02/2026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D97C9D-94DF-5709-B0E2-0CDCAFB646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2DC61D-3EE3-0913-CD5A-85E28E9B60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BF002DF-6156-48E4-BC75-50CB84F7F3CD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179673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5FBE692-9E15-D93D-C4CB-00E83BA0A589}"/>
              </a:ext>
            </a:extLst>
          </p:cNvPr>
          <p:cNvSpPr txBox="1"/>
          <p:nvPr/>
        </p:nvSpPr>
        <p:spPr>
          <a:xfrm>
            <a:off x="1594462" y="231081"/>
            <a:ext cx="85458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Patient number 53 </a:t>
            </a:r>
          </a:p>
          <a:p>
            <a:pPr algn="ctr"/>
            <a:r>
              <a:rPr lang="en-US" b="1" dirty="0"/>
              <a:t>Variant: SLC26A4:NM_00041:exon3:c.269T:p.S90L	</a:t>
            </a:r>
            <a:endParaRPr lang="en-SG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FD81D46-473E-1762-0883-C0DDDE0BD2A8}"/>
              </a:ext>
            </a:extLst>
          </p:cNvPr>
          <p:cNvSpPr txBox="1"/>
          <p:nvPr/>
        </p:nvSpPr>
        <p:spPr>
          <a:xfrm>
            <a:off x="7697029" y="927330"/>
            <a:ext cx="2721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verse read</a:t>
            </a:r>
            <a:endParaRPr lang="en-SG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706DD84-87CA-2356-EE30-1BD8EE06CCA0}"/>
              </a:ext>
            </a:extLst>
          </p:cNvPr>
          <p:cNvSpPr txBox="1"/>
          <p:nvPr/>
        </p:nvSpPr>
        <p:spPr>
          <a:xfrm>
            <a:off x="1447821" y="877412"/>
            <a:ext cx="2721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orward read</a:t>
            </a:r>
            <a:endParaRPr lang="en-SG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DC6CEAC-D27B-583A-72A3-8B3E9C4DDB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0588" y="1208644"/>
            <a:ext cx="4702680" cy="244087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D58F357-C695-DFF5-B92E-6DE327BE96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8734" y="1208644"/>
            <a:ext cx="4459749" cy="244087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AFBBC98-5EC9-FE8A-918B-639D3E610EEC}"/>
              </a:ext>
            </a:extLst>
          </p:cNvPr>
          <p:cNvSpPr txBox="1"/>
          <p:nvPr/>
        </p:nvSpPr>
        <p:spPr>
          <a:xfrm>
            <a:off x="1594462" y="3746167"/>
            <a:ext cx="99906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Variant: SLC26A4:NM_000441:exon18:c.C2086T:p.Q696X		</a:t>
            </a:r>
            <a:endParaRPr lang="en-SG" b="1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DBF3E2D-F8C8-D973-4B4B-E3AC2BB3A0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61595" y="4115499"/>
            <a:ext cx="4870661" cy="254767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68AFD4F-6342-5689-C560-7F36E09F350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95552" y="4222302"/>
            <a:ext cx="4257498" cy="2440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93201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F2D0EE9-F8B3-59FF-138F-83FD1FAEC5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6800" y="1326834"/>
            <a:ext cx="4514850" cy="460724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B62A6B9-C50B-0703-838A-56DF074A34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77321" y="1326833"/>
            <a:ext cx="5294613" cy="460724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B74F488-644F-56A0-6755-E9110A0BD6FB}"/>
              </a:ext>
            </a:extLst>
          </p:cNvPr>
          <p:cNvSpPr txBox="1"/>
          <p:nvPr/>
        </p:nvSpPr>
        <p:spPr>
          <a:xfrm>
            <a:off x="8273467" y="827960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verse read</a:t>
            </a:r>
            <a:endParaRPr lang="en-SG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6D4B8C7-D48C-B20F-4C6A-53782949E39D}"/>
              </a:ext>
            </a:extLst>
          </p:cNvPr>
          <p:cNvSpPr txBox="1"/>
          <p:nvPr/>
        </p:nvSpPr>
        <p:spPr>
          <a:xfrm>
            <a:off x="2486016" y="806767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orward read</a:t>
            </a:r>
            <a:endParaRPr lang="en-SG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1663F29-C769-F963-5AC0-5B9D666B5FC6}"/>
              </a:ext>
            </a:extLst>
          </p:cNvPr>
          <p:cNvSpPr/>
          <p:nvPr/>
        </p:nvSpPr>
        <p:spPr>
          <a:xfrm>
            <a:off x="2977710" y="458628"/>
            <a:ext cx="57246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SG" b="1" dirty="0"/>
              <a:t>CEACAM16:NM_001039213:exon6:c.G1012T:p.V338L	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F76B53F-B406-FAA7-AFDC-9F5AC11E5495}"/>
              </a:ext>
            </a:extLst>
          </p:cNvPr>
          <p:cNvSpPr txBox="1"/>
          <p:nvPr/>
        </p:nvSpPr>
        <p:spPr>
          <a:xfrm>
            <a:off x="2646493" y="162817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Patient number 96</a:t>
            </a:r>
          </a:p>
        </p:txBody>
      </p:sp>
    </p:spTree>
    <p:extLst>
      <p:ext uri="{BB962C8B-B14F-4D97-AF65-F5344CB8AC3E}">
        <p14:creationId xmlns:p14="http://schemas.microsoft.com/office/powerpoint/2010/main" val="2128303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29CAF92-5E81-EF8F-5C81-85DDAEDC90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2951" y="1756427"/>
            <a:ext cx="5081166" cy="378712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5449C73-1B29-A8C3-D9DE-5E328399C0A7}"/>
              </a:ext>
            </a:extLst>
          </p:cNvPr>
          <p:cNvSpPr txBox="1"/>
          <p:nvPr/>
        </p:nvSpPr>
        <p:spPr>
          <a:xfrm>
            <a:off x="2726639" y="1135274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orward read</a:t>
            </a:r>
            <a:endParaRPr lang="en-SG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43C472F-7734-AB3C-0D4A-6CA7B2F21410}"/>
              </a:ext>
            </a:extLst>
          </p:cNvPr>
          <p:cNvSpPr txBox="1"/>
          <p:nvPr/>
        </p:nvSpPr>
        <p:spPr>
          <a:xfrm>
            <a:off x="2726639" y="534906"/>
            <a:ext cx="67387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Variant: GJB2:NM_004004:exon2:c.G109A:p.V37I</a:t>
            </a:r>
            <a:endParaRPr lang="en-SG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F42FA51-F820-AC80-55F4-B31207D5CD4B}"/>
              </a:ext>
            </a:extLst>
          </p:cNvPr>
          <p:cNvSpPr txBox="1"/>
          <p:nvPr/>
        </p:nvSpPr>
        <p:spPr>
          <a:xfrm>
            <a:off x="8213646" y="1188301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verse read</a:t>
            </a:r>
            <a:endParaRPr lang="en-SG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9F92894-9FF9-45B1-6AB9-757D7FC4A1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5999" y="1756427"/>
            <a:ext cx="5755502" cy="378712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3283EEA-5AC7-87E4-01A1-8BEBE2806CEC}"/>
              </a:ext>
            </a:extLst>
          </p:cNvPr>
          <p:cNvSpPr txBox="1"/>
          <p:nvPr/>
        </p:nvSpPr>
        <p:spPr>
          <a:xfrm>
            <a:off x="2962275" y="155182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Patient number 105 </a:t>
            </a:r>
          </a:p>
        </p:txBody>
      </p:sp>
    </p:spTree>
    <p:extLst>
      <p:ext uri="{BB962C8B-B14F-4D97-AF65-F5344CB8AC3E}">
        <p14:creationId xmlns:p14="http://schemas.microsoft.com/office/powerpoint/2010/main" val="10246904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0A8C0B3-DCFE-334D-3469-B08BC070A741}"/>
              </a:ext>
            </a:extLst>
          </p:cNvPr>
          <p:cNvSpPr txBox="1"/>
          <p:nvPr/>
        </p:nvSpPr>
        <p:spPr>
          <a:xfrm>
            <a:off x="2590832" y="613257"/>
            <a:ext cx="69953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Variant: GJB2:NM_004004:exon2:c.235delC:p.L79Cfs*3</a:t>
            </a:r>
            <a:endParaRPr lang="en-SG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4592D82-9FC7-8333-C5FC-EF4FF4BA28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8379" y="1577374"/>
            <a:ext cx="5185114" cy="353454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49B9FA0-5AB6-247A-F92A-287A656710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49852" y="1577374"/>
            <a:ext cx="5247764" cy="353454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5D85D45-77C0-0F51-853A-39C23C7B649D}"/>
              </a:ext>
            </a:extLst>
          </p:cNvPr>
          <p:cNvSpPr txBox="1"/>
          <p:nvPr/>
        </p:nvSpPr>
        <p:spPr>
          <a:xfrm>
            <a:off x="2590832" y="1038686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orward read</a:t>
            </a:r>
            <a:endParaRPr lang="en-SG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D4EB337-C151-B624-C415-5991EF2DE7B0}"/>
              </a:ext>
            </a:extLst>
          </p:cNvPr>
          <p:cNvSpPr txBox="1"/>
          <p:nvPr/>
        </p:nvSpPr>
        <p:spPr>
          <a:xfrm>
            <a:off x="8141151" y="1129721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verse read</a:t>
            </a:r>
            <a:endParaRPr lang="en-SG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81CBCFF-666E-CF70-B3B2-0188855AE4AD}"/>
              </a:ext>
            </a:extLst>
          </p:cNvPr>
          <p:cNvSpPr txBox="1"/>
          <p:nvPr/>
        </p:nvSpPr>
        <p:spPr>
          <a:xfrm>
            <a:off x="3048000" y="19202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Patient number 96</a:t>
            </a:r>
          </a:p>
        </p:txBody>
      </p:sp>
    </p:spTree>
    <p:extLst>
      <p:ext uri="{BB962C8B-B14F-4D97-AF65-F5344CB8AC3E}">
        <p14:creationId xmlns:p14="http://schemas.microsoft.com/office/powerpoint/2010/main" val="39955934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056784D-D11A-A597-30BA-A6DE251B184F}"/>
              </a:ext>
            </a:extLst>
          </p:cNvPr>
          <p:cNvSpPr txBox="1"/>
          <p:nvPr/>
        </p:nvSpPr>
        <p:spPr>
          <a:xfrm>
            <a:off x="2395974" y="1229380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orward read</a:t>
            </a:r>
            <a:endParaRPr lang="en-SG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F44911D-DC82-8A0E-24F3-5B0522C5C35F}"/>
              </a:ext>
            </a:extLst>
          </p:cNvPr>
          <p:cNvSpPr txBox="1"/>
          <p:nvPr/>
        </p:nvSpPr>
        <p:spPr>
          <a:xfrm>
            <a:off x="7972184" y="1229380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verse read</a:t>
            </a:r>
            <a:endParaRPr lang="en-SG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8AC4FF6-3A6F-A5F3-5E62-500A11DBAE47}"/>
              </a:ext>
            </a:extLst>
          </p:cNvPr>
          <p:cNvSpPr txBox="1"/>
          <p:nvPr/>
        </p:nvSpPr>
        <p:spPr>
          <a:xfrm>
            <a:off x="2026497" y="804884"/>
            <a:ext cx="81390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Variant: SLC26A4:NM_000441:exon6:c.C706G:p.L236V 	</a:t>
            </a:r>
            <a:endParaRPr lang="en-SG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57F0891-0D10-54CA-FA0A-31F6C356A0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00800" y="1854182"/>
            <a:ext cx="4591051" cy="384242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C62A768-113D-8B16-A4E8-1BF2E3FE13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0759" y="1854182"/>
            <a:ext cx="4973791" cy="387692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294B9AB-7B3B-1F0F-8EBE-53F28FBE58F6}"/>
              </a:ext>
            </a:extLst>
          </p:cNvPr>
          <p:cNvSpPr txBox="1"/>
          <p:nvPr/>
        </p:nvSpPr>
        <p:spPr>
          <a:xfrm>
            <a:off x="3048000" y="19202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Patient number 83</a:t>
            </a:r>
          </a:p>
        </p:txBody>
      </p:sp>
    </p:spTree>
    <p:extLst>
      <p:ext uri="{BB962C8B-B14F-4D97-AF65-F5344CB8AC3E}">
        <p14:creationId xmlns:p14="http://schemas.microsoft.com/office/powerpoint/2010/main" val="24585203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C8564B5-2283-5698-E0DB-8BC2DCC3A3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8908" y="1159041"/>
            <a:ext cx="4187491" cy="26670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96381DE-A0A2-FB2F-A005-F9A27CCAD7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19875" y="1280743"/>
            <a:ext cx="4187492" cy="233875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DFE423B-4AAB-85FB-80DD-C4CE57E1AF93}"/>
              </a:ext>
            </a:extLst>
          </p:cNvPr>
          <p:cNvSpPr txBox="1"/>
          <p:nvPr/>
        </p:nvSpPr>
        <p:spPr>
          <a:xfrm>
            <a:off x="2213819" y="605043"/>
            <a:ext cx="8023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OTOF:NM_194322:exon22:c.G3028C:p.E1010Q 	</a:t>
            </a:r>
            <a:endParaRPr lang="en-SG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D4B6B47-4349-4234-5522-0A610F698B01}"/>
              </a:ext>
            </a:extLst>
          </p:cNvPr>
          <p:cNvSpPr txBox="1"/>
          <p:nvPr/>
        </p:nvSpPr>
        <p:spPr>
          <a:xfrm>
            <a:off x="2632549" y="911410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orward read</a:t>
            </a:r>
            <a:endParaRPr lang="en-SG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3D6BEB4-0715-C188-8222-DDBB4CFE2BC8}"/>
              </a:ext>
            </a:extLst>
          </p:cNvPr>
          <p:cNvSpPr txBox="1"/>
          <p:nvPr/>
        </p:nvSpPr>
        <p:spPr>
          <a:xfrm>
            <a:off x="7737854" y="974375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verse read</a:t>
            </a:r>
            <a:endParaRPr lang="en-SG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FFDBA08-0326-36B5-C859-CF74D0C0279D}"/>
              </a:ext>
            </a:extLst>
          </p:cNvPr>
          <p:cNvSpPr txBox="1"/>
          <p:nvPr/>
        </p:nvSpPr>
        <p:spPr>
          <a:xfrm>
            <a:off x="3048000" y="19202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Patient number 72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9B0A96C-C6CB-EB57-1F8A-97A343B1BF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76835" y="4195374"/>
            <a:ext cx="4671761" cy="242818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88E1019-F47C-8171-815C-C5EF78DBA27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82072" y="4195373"/>
            <a:ext cx="4293725" cy="237982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6508C13-7C06-B6F4-4BB6-7DE7F17FB9D1}"/>
              </a:ext>
            </a:extLst>
          </p:cNvPr>
          <p:cNvSpPr txBox="1"/>
          <p:nvPr/>
        </p:nvSpPr>
        <p:spPr>
          <a:xfrm>
            <a:off x="2632549" y="3826041"/>
            <a:ext cx="76844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OTOF c.4023+1G&gt;A		</a:t>
            </a:r>
            <a:endParaRPr lang="en-SG" b="1" dirty="0"/>
          </a:p>
        </p:txBody>
      </p:sp>
    </p:spTree>
    <p:extLst>
      <p:ext uri="{BB962C8B-B14F-4D97-AF65-F5344CB8AC3E}">
        <p14:creationId xmlns:p14="http://schemas.microsoft.com/office/powerpoint/2010/main" val="15119394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6CC510E-B49D-EA80-9917-BBC8DF230F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5596" y="1375620"/>
            <a:ext cx="5672699" cy="428776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98AC9AD-43FD-4FAB-A8AF-C640A9FAE772}"/>
              </a:ext>
            </a:extLst>
          </p:cNvPr>
          <p:cNvSpPr txBox="1"/>
          <p:nvPr/>
        </p:nvSpPr>
        <p:spPr>
          <a:xfrm>
            <a:off x="2248450" y="1006288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orward read</a:t>
            </a:r>
            <a:endParaRPr lang="en-SG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A3D3EDA-9E2C-72EA-4ABA-37C640E1ADB9}"/>
              </a:ext>
            </a:extLst>
          </p:cNvPr>
          <p:cNvSpPr txBox="1"/>
          <p:nvPr/>
        </p:nvSpPr>
        <p:spPr>
          <a:xfrm>
            <a:off x="2790361" y="682248"/>
            <a:ext cx="76243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WFS1:NM_001145853:exon8:c.A2141G:p.N714S	</a:t>
            </a:r>
            <a:endParaRPr lang="en-SG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4655A8F-700E-AF46-B889-25912C20B73D}"/>
              </a:ext>
            </a:extLst>
          </p:cNvPr>
          <p:cNvSpPr txBox="1"/>
          <p:nvPr/>
        </p:nvSpPr>
        <p:spPr>
          <a:xfrm>
            <a:off x="8280287" y="1006288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verse read</a:t>
            </a:r>
            <a:endParaRPr lang="en-SG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FCE9F19-AABD-0C71-5FA2-804599D297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02550" y="1375620"/>
            <a:ext cx="5365316" cy="428776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3A23E00-12F1-3A47-E585-40A5503E840C}"/>
              </a:ext>
            </a:extLst>
          </p:cNvPr>
          <p:cNvSpPr txBox="1"/>
          <p:nvPr/>
        </p:nvSpPr>
        <p:spPr>
          <a:xfrm>
            <a:off x="3048000" y="19202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Patient number 73</a:t>
            </a:r>
          </a:p>
        </p:txBody>
      </p:sp>
    </p:spTree>
    <p:extLst>
      <p:ext uri="{BB962C8B-B14F-4D97-AF65-F5344CB8AC3E}">
        <p14:creationId xmlns:p14="http://schemas.microsoft.com/office/powerpoint/2010/main" val="41182389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FAE9B04-96D2-C49B-D78C-2E935DE16F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6295" y="1619250"/>
            <a:ext cx="4819650" cy="430244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386AEBC-1258-FC43-293C-70F8577D43C7}"/>
              </a:ext>
            </a:extLst>
          </p:cNvPr>
          <p:cNvSpPr txBox="1"/>
          <p:nvPr/>
        </p:nvSpPr>
        <p:spPr>
          <a:xfrm>
            <a:off x="2486016" y="997267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orward read</a:t>
            </a:r>
            <a:endParaRPr lang="en-SG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233971-F008-F58A-16B5-963ED3EA7ACC}"/>
              </a:ext>
            </a:extLst>
          </p:cNvPr>
          <p:cNvSpPr txBox="1"/>
          <p:nvPr/>
        </p:nvSpPr>
        <p:spPr>
          <a:xfrm>
            <a:off x="8582016" y="997267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verse read</a:t>
            </a:r>
            <a:endParaRPr lang="en-SG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489FCCC-566E-090E-C20E-28EE6880C01D}"/>
              </a:ext>
            </a:extLst>
          </p:cNvPr>
          <p:cNvSpPr/>
          <p:nvPr/>
        </p:nvSpPr>
        <p:spPr>
          <a:xfrm>
            <a:off x="3329559" y="609957"/>
            <a:ext cx="57246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SG" b="1" dirty="0"/>
              <a:t>MYO7A:NM_000260:exon48:c.G6529A:p.G2177R	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2C91E1E-B69A-6571-8D61-13C193EE8F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06253" y="1619248"/>
            <a:ext cx="5295900" cy="430244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12A6912-B479-D349-DE8F-ECC6069AEF7B}"/>
              </a:ext>
            </a:extLst>
          </p:cNvPr>
          <p:cNvSpPr txBox="1"/>
          <p:nvPr/>
        </p:nvSpPr>
        <p:spPr>
          <a:xfrm>
            <a:off x="3048000" y="19202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Patient number 62</a:t>
            </a:r>
          </a:p>
        </p:txBody>
      </p:sp>
    </p:spTree>
    <p:extLst>
      <p:ext uri="{BB962C8B-B14F-4D97-AF65-F5344CB8AC3E}">
        <p14:creationId xmlns:p14="http://schemas.microsoft.com/office/powerpoint/2010/main" val="35288696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4FF2715-5C06-3890-4AE4-68BCE3FC86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8219" y="1659969"/>
            <a:ext cx="4040505" cy="4498433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C9C40B21-9032-22D7-0ECA-8F057E443C7A}"/>
              </a:ext>
            </a:extLst>
          </p:cNvPr>
          <p:cNvSpPr/>
          <p:nvPr/>
        </p:nvSpPr>
        <p:spPr>
          <a:xfrm>
            <a:off x="3018471" y="719732"/>
            <a:ext cx="57246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SG" b="1" dirty="0"/>
              <a:t>SLC17A8:NM_001145288:exon6:c.G737C:p.G246A	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E12EA2E-2A13-4AA6-9EA7-27C751EFD799}"/>
              </a:ext>
            </a:extLst>
          </p:cNvPr>
          <p:cNvSpPr txBox="1"/>
          <p:nvPr/>
        </p:nvSpPr>
        <p:spPr>
          <a:xfrm>
            <a:off x="1800216" y="1144071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orward read</a:t>
            </a:r>
            <a:endParaRPr lang="en-SG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725927D-6E8A-736C-C055-E0682927A334}"/>
              </a:ext>
            </a:extLst>
          </p:cNvPr>
          <p:cNvSpPr txBox="1"/>
          <p:nvPr/>
        </p:nvSpPr>
        <p:spPr>
          <a:xfrm>
            <a:off x="7875502" y="1144071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verse read</a:t>
            </a:r>
            <a:endParaRPr lang="en-SG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68EFAAE-D68B-F986-EAFC-769046ECAC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60410" y="1659969"/>
            <a:ext cx="4455851" cy="447829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EE8B1CB-2A16-1E6F-5B7F-FF042BBA41D2}"/>
              </a:ext>
            </a:extLst>
          </p:cNvPr>
          <p:cNvSpPr txBox="1"/>
          <p:nvPr/>
        </p:nvSpPr>
        <p:spPr>
          <a:xfrm>
            <a:off x="2781300" y="2038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Patient number 62</a:t>
            </a:r>
          </a:p>
        </p:txBody>
      </p:sp>
    </p:spTree>
    <p:extLst>
      <p:ext uri="{BB962C8B-B14F-4D97-AF65-F5344CB8AC3E}">
        <p14:creationId xmlns:p14="http://schemas.microsoft.com/office/powerpoint/2010/main" val="12946685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107F4B6-6195-444E-3024-D97C5AB2B4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0675" y="1400175"/>
            <a:ext cx="4505325" cy="4476066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A45DEDE-9241-3917-73D0-C86108FA53EA}"/>
              </a:ext>
            </a:extLst>
          </p:cNvPr>
          <p:cNvSpPr/>
          <p:nvPr/>
        </p:nvSpPr>
        <p:spPr>
          <a:xfrm>
            <a:off x="3190809" y="612427"/>
            <a:ext cx="57246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TMPRSS3:NM_032404:exon3:c.T170C:p.L57S	</a:t>
            </a:r>
            <a:endParaRPr lang="en-SG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6479524-1081-1BA7-92F2-E0DEDDA0D03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2778" y="1400175"/>
            <a:ext cx="4705350" cy="447606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B7668BD-E311-0A85-86A2-955F10D34639}"/>
              </a:ext>
            </a:extLst>
          </p:cNvPr>
          <p:cNvSpPr txBox="1"/>
          <p:nvPr/>
        </p:nvSpPr>
        <p:spPr>
          <a:xfrm>
            <a:off x="8155349" y="981759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verse read</a:t>
            </a:r>
            <a:endParaRPr lang="en-SG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C3057BB-3CCA-CFA9-039B-81ED6A839C80}"/>
              </a:ext>
            </a:extLst>
          </p:cNvPr>
          <p:cNvSpPr txBox="1"/>
          <p:nvPr/>
        </p:nvSpPr>
        <p:spPr>
          <a:xfrm>
            <a:off x="2617460" y="926067"/>
            <a:ext cx="1520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orward read</a:t>
            </a:r>
            <a:endParaRPr lang="en-SG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9C43F8A-89A8-6E8A-B246-8CBEB1F065B5}"/>
              </a:ext>
            </a:extLst>
          </p:cNvPr>
          <p:cNvSpPr txBox="1"/>
          <p:nvPr/>
        </p:nvSpPr>
        <p:spPr>
          <a:xfrm>
            <a:off x="2646493" y="162817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Patient number 99</a:t>
            </a:r>
          </a:p>
        </p:txBody>
      </p:sp>
    </p:spTree>
    <p:extLst>
      <p:ext uri="{BB962C8B-B14F-4D97-AF65-F5344CB8AC3E}">
        <p14:creationId xmlns:p14="http://schemas.microsoft.com/office/powerpoint/2010/main" val="1085435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265</Words>
  <Application>Microsoft Office PowerPoint</Application>
  <PresentationFormat>Widescreen</PresentationFormat>
  <Paragraphs>42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eng Mei Shuang /BMS</dc:creator>
  <cp:lastModifiedBy>Lim Che Kang (SGH)</cp:lastModifiedBy>
  <cp:revision>3</cp:revision>
  <dcterms:created xsi:type="dcterms:W3CDTF">2026-02-03T04:10:29Z</dcterms:created>
  <dcterms:modified xsi:type="dcterms:W3CDTF">2026-02-11T07:55:29Z</dcterms:modified>
</cp:coreProperties>
</file>